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0.wmf" ContentType="image/x-wmf"/>
  <Override PartName="/ppt/media/image7.png" ContentType="image/png"/>
  <Override PartName="/ppt/media/image11.wmf" ContentType="image/x-wmf"/>
  <Override PartName="/ppt/media/image8.png" ContentType="image/png"/>
  <Override PartName="/ppt/media/image12.wmf" ContentType="image/x-wmf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3716000" cy="17373600"/>
  <p:notesSz cx="6889750" cy="100218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90400" cy="1002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168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l-GR" sz="13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1252080"/>
            <a:ext cx="2670120" cy="3382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168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F6EC2855-BA05-4518-A117-7DD2D5D23A23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99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28B0761D-6824-4111-A033-30470CBAFE84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1738B-D122-4F6C-9DE7-1958CCAA03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E6C4E-7BB2-475D-BBAD-D21C21ED34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5D0E4-B186-4534-9C16-EF4D4AD370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81B85-6365-435F-9733-5E4E00D152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51"/>
              </a:spcBef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8DCE1-1728-41B0-8267-72AE833894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032CF-0F1B-4DD0-A9D0-6849CC7C87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F0897-60F4-4765-BC0D-837A952FFD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B75E6-1D0F-4DFE-A563-ED32D4C5B0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95160"/>
            <a:ext cx="12344400" cy="1342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51"/>
              </a:spcBef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57253-FA28-44B3-864C-C1EC7B790E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25989-7E4B-4D4B-8CB4-589660A624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9A6C9-C2EB-4B43-AAAD-9213EE7378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F11B9-72D5-4F89-8A04-7A0458ADB9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marL="665280" indent="-66528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1" marL="1442880" indent="-55404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2" marL="2219400" indent="-44316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3" marL="3108240" indent="-44280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4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5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6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101720"/>
            <a:ext cx="4343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9EA3333F-1ACF-4E6D-B077-D6D8634C4117}" type="slidenum">
              <a:rPr b="0" lang="en-US" sz="2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9.wmf"/><Relationship Id="rId12" Type="http://schemas.openxmlformats.org/officeDocument/2006/relationships/image" Target="../media/image11.wmf"/><Relationship Id="rId13" Type="http://schemas.openxmlformats.org/officeDocument/2006/relationships/image" Target="../media/image9.wmf"/><Relationship Id="rId14" Type="http://schemas.openxmlformats.org/officeDocument/2006/relationships/image" Target="../media/image9.wmf"/><Relationship Id="rId15" Type="http://schemas.openxmlformats.org/officeDocument/2006/relationships/image" Target="../media/image12.wmf"/><Relationship Id="rId16" Type="http://schemas.openxmlformats.org/officeDocument/2006/relationships/image" Target="../media/image9.wmf"/><Relationship Id="rId17" Type="http://schemas.openxmlformats.org/officeDocument/2006/relationships/image" Target="../media/image9.wmf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Ομάδα 19"/>
          <p:cNvGrpSpPr/>
          <p:nvPr/>
        </p:nvGrpSpPr>
        <p:grpSpPr>
          <a:xfrm>
            <a:off x="152280" y="622440"/>
            <a:ext cx="13535280" cy="4410000"/>
            <a:chOff x="152280" y="622440"/>
            <a:chExt cx="13535280" cy="4410000"/>
          </a:xfrm>
        </p:grpSpPr>
        <p:sp>
          <p:nvSpPr>
            <p:cNvPr id="49" name="71 - TextBox"/>
            <p:cNvSpPr/>
            <p:nvPr/>
          </p:nvSpPr>
          <p:spPr>
            <a:xfrm>
              <a:off x="160920" y="2143080"/>
              <a:ext cx="38736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42 - TextBox"/>
            <p:cNvSpPr/>
            <p:nvPr/>
          </p:nvSpPr>
          <p:spPr>
            <a:xfrm>
              <a:off x="152280" y="622440"/>
              <a:ext cx="63468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Ομάδα 34"/>
            <p:cNvGrpSpPr/>
            <p:nvPr/>
          </p:nvGrpSpPr>
          <p:grpSpPr>
            <a:xfrm>
              <a:off x="1669680" y="925560"/>
              <a:ext cx="5151600" cy="914400"/>
              <a:chOff x="1669680" y="925560"/>
              <a:chExt cx="5151600" cy="914400"/>
            </a:xfrm>
          </p:grpSpPr>
          <p:sp>
            <p:nvSpPr>
              <p:cNvPr id="52" name="Line 5"/>
              <p:cNvSpPr/>
              <p:nvPr/>
            </p:nvSpPr>
            <p:spPr>
              <a:xfrm>
                <a:off x="4357440" y="1341000"/>
                <a:ext cx="0" cy="24228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6"/>
              <p:cNvSpPr/>
              <p:nvPr/>
            </p:nvSpPr>
            <p:spPr>
              <a:xfrm>
                <a:off x="3486960" y="1349280"/>
                <a:ext cx="0" cy="24228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Freeform 7"/>
              <p:cNvSpPr/>
              <p:nvPr/>
            </p:nvSpPr>
            <p:spPr>
              <a:xfrm>
                <a:off x="1669680" y="1465920"/>
                <a:ext cx="2817360" cy="38880"/>
              </a:xfrm>
              <a:custGeom>
                <a:avLst/>
                <a:gdLst>
                  <a:gd name="textAreaLeft" fmla="*/ 0 w 2817360"/>
                  <a:gd name="textAreaRight" fmla="*/ 2817720 w 2817360"/>
                  <a:gd name="textAreaTop" fmla="*/ 0 h 38880"/>
                  <a:gd name="textAreaBottom" fmla="*/ 39240 h 38880"/>
                </a:gdLst>
                <a:ahLst/>
                <a:rect l="textAreaLeft" t="textAreaTop" r="textAreaRight" b="textAreaBottom"/>
                <a:pathLst>
                  <a:path w="2140" h="34">
                    <a:moveTo>
                      <a:pt x="0" y="12"/>
                    </a:moveTo>
                    <a:lnTo>
                      <a:pt x="2110" y="12"/>
                    </a:lnTo>
                    <a:lnTo>
                      <a:pt x="2110" y="22"/>
                    </a:lnTo>
                    <a:lnTo>
                      <a:pt x="0" y="22"/>
                    </a:lnTo>
                    <a:lnTo>
                      <a:pt x="0" y="12"/>
                    </a:lnTo>
                    <a:close/>
                    <a:moveTo>
                      <a:pt x="2104" y="0"/>
                    </a:moveTo>
                    <a:lnTo>
                      <a:pt x="2140" y="17"/>
                    </a:lnTo>
                    <a:lnTo>
                      <a:pt x="2104" y="34"/>
                    </a:lnTo>
                    <a:lnTo>
                      <a:pt x="2104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9"/>
              <p:cNvSpPr/>
              <p:nvPr/>
            </p:nvSpPr>
            <p:spPr>
              <a:xfrm>
                <a:off x="3164040" y="1596240"/>
                <a:ext cx="59220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0" lang="el-GR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AY 1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11"/>
              <p:cNvSpPr/>
              <p:nvPr/>
            </p:nvSpPr>
            <p:spPr>
              <a:xfrm>
                <a:off x="4150800" y="1595160"/>
                <a:ext cx="59220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0" lang="el-GR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AY 2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13"/>
              <p:cNvSpPr/>
              <p:nvPr/>
            </p:nvSpPr>
            <p:spPr>
              <a:xfrm>
                <a:off x="2186280" y="1595160"/>
                <a:ext cx="59220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0" lang="el-GR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AY 0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14"/>
              <p:cNvSpPr/>
              <p:nvPr/>
            </p:nvSpPr>
            <p:spPr>
              <a:xfrm>
                <a:off x="2613240" y="1349280"/>
                <a:ext cx="0" cy="24228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Rectangle 16"/>
              <p:cNvSpPr/>
              <p:nvPr/>
            </p:nvSpPr>
            <p:spPr>
              <a:xfrm>
                <a:off x="1753560" y="1336680"/>
                <a:ext cx="831240" cy="133560"/>
              </a:xfrm>
              <a:prstGeom prst="rect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Rectangle 17"/>
              <p:cNvSpPr/>
              <p:nvPr/>
            </p:nvSpPr>
            <p:spPr>
              <a:xfrm>
                <a:off x="3506400" y="1162080"/>
                <a:ext cx="831240" cy="14616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18"/>
              <p:cNvSpPr/>
              <p:nvPr/>
            </p:nvSpPr>
            <p:spPr>
              <a:xfrm>
                <a:off x="4988160" y="1532160"/>
                <a:ext cx="252360" cy="110880"/>
              </a:xfrm>
              <a:prstGeom prst="rect">
                <a:avLst/>
              </a:prstGeom>
              <a:solidFill>
                <a:srgbClr val="00b05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19"/>
              <p:cNvSpPr/>
              <p:nvPr/>
            </p:nvSpPr>
            <p:spPr>
              <a:xfrm>
                <a:off x="4988160" y="966240"/>
                <a:ext cx="252360" cy="11088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20"/>
              <p:cNvSpPr/>
              <p:nvPr/>
            </p:nvSpPr>
            <p:spPr>
              <a:xfrm>
                <a:off x="5400360" y="1469520"/>
                <a:ext cx="14209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mplete</a:t>
                </a: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edium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21"/>
              <p:cNvSpPr/>
              <p:nvPr/>
            </p:nvSpPr>
            <p:spPr>
              <a:xfrm>
                <a:off x="5389200" y="925560"/>
                <a:ext cx="12441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rug compoun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24"/>
              <p:cNvSpPr/>
              <p:nvPr/>
            </p:nvSpPr>
            <p:spPr>
              <a:xfrm>
                <a:off x="4988160" y="1260000"/>
                <a:ext cx="252360" cy="110880"/>
              </a:xfrm>
              <a:prstGeom prst="rect">
                <a:avLst/>
              </a:prstGeom>
              <a:solidFill>
                <a:srgbClr val="558ed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25"/>
              <p:cNvSpPr/>
              <p:nvPr/>
            </p:nvSpPr>
            <p:spPr>
              <a:xfrm>
                <a:off x="5342760" y="1218960"/>
                <a:ext cx="317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15"/>
              <p:cNvSpPr/>
              <p:nvPr/>
            </p:nvSpPr>
            <p:spPr>
              <a:xfrm>
                <a:off x="2632320" y="1338480"/>
                <a:ext cx="831240" cy="136080"/>
              </a:xfrm>
              <a:prstGeom prst="rect">
                <a:avLst/>
              </a:prstGeom>
              <a:solidFill>
                <a:srgbClr val="558ed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15"/>
              <p:cNvSpPr/>
              <p:nvPr/>
            </p:nvSpPr>
            <p:spPr>
              <a:xfrm>
                <a:off x="3503880" y="1333080"/>
                <a:ext cx="831240" cy="136080"/>
              </a:xfrm>
              <a:prstGeom prst="rect">
                <a:avLst/>
              </a:prstGeom>
              <a:solidFill>
                <a:srgbClr val="558ed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69" name="Picture 47" descr=""/>
            <p:cNvPicPr/>
            <p:nvPr/>
          </p:nvPicPr>
          <p:blipFill>
            <a:blip r:embed="rId1"/>
            <a:stretch/>
          </p:blipFill>
          <p:spPr>
            <a:xfrm>
              <a:off x="3857400" y="2562480"/>
              <a:ext cx="3262320" cy="246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48" descr=""/>
            <p:cNvPicPr/>
            <p:nvPr/>
          </p:nvPicPr>
          <p:blipFill>
            <a:blip r:embed="rId2"/>
            <a:stretch/>
          </p:blipFill>
          <p:spPr>
            <a:xfrm>
              <a:off x="7120080" y="2535480"/>
              <a:ext cx="3262320" cy="246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49" descr=""/>
            <p:cNvPicPr/>
            <p:nvPr/>
          </p:nvPicPr>
          <p:blipFill>
            <a:blip r:embed="rId3"/>
            <a:stretch/>
          </p:blipFill>
          <p:spPr>
            <a:xfrm>
              <a:off x="10425240" y="2535480"/>
              <a:ext cx="3262320" cy="246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50" descr=""/>
            <p:cNvPicPr/>
            <p:nvPr/>
          </p:nvPicPr>
          <p:blipFill>
            <a:blip r:embed="rId4"/>
            <a:stretch/>
          </p:blipFill>
          <p:spPr>
            <a:xfrm>
              <a:off x="499680" y="2562480"/>
              <a:ext cx="3262320" cy="2469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3" name="Rectangle 29"/>
          <p:cNvSpPr/>
          <p:nvPr/>
        </p:nvSpPr>
        <p:spPr>
          <a:xfrm>
            <a:off x="138240" y="12600"/>
            <a:ext cx="67658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Additional file 1: Figure  S1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Ομάδα 17"/>
          <p:cNvGrpSpPr/>
          <p:nvPr/>
        </p:nvGrpSpPr>
        <p:grpSpPr>
          <a:xfrm>
            <a:off x="206280" y="10015560"/>
            <a:ext cx="13365360" cy="3063960"/>
            <a:chOff x="206280" y="10015560"/>
            <a:chExt cx="13365360" cy="3063960"/>
          </a:xfrm>
        </p:grpSpPr>
        <p:pic>
          <p:nvPicPr>
            <p:cNvPr id="75" name="Picture 51" descr=""/>
            <p:cNvPicPr/>
            <p:nvPr/>
          </p:nvPicPr>
          <p:blipFill>
            <a:blip r:embed="rId5"/>
            <a:stretch/>
          </p:blipFill>
          <p:spPr>
            <a:xfrm>
              <a:off x="3841560" y="10609200"/>
              <a:ext cx="3260520" cy="2470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52" descr=""/>
            <p:cNvPicPr/>
            <p:nvPr/>
          </p:nvPicPr>
          <p:blipFill>
            <a:blip r:embed="rId6"/>
            <a:stretch/>
          </p:blipFill>
          <p:spPr>
            <a:xfrm>
              <a:off x="7091280" y="10609200"/>
              <a:ext cx="3262320" cy="2470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53" descr=""/>
            <p:cNvPicPr/>
            <p:nvPr/>
          </p:nvPicPr>
          <p:blipFill>
            <a:blip r:embed="rId7"/>
            <a:stretch/>
          </p:blipFill>
          <p:spPr>
            <a:xfrm>
              <a:off x="10311120" y="10588680"/>
              <a:ext cx="3260520" cy="2470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54" descr=""/>
            <p:cNvPicPr/>
            <p:nvPr/>
          </p:nvPicPr>
          <p:blipFill>
            <a:blip r:embed="rId8"/>
            <a:stretch/>
          </p:blipFill>
          <p:spPr>
            <a:xfrm>
              <a:off x="482400" y="10555200"/>
              <a:ext cx="3260520" cy="2470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71 - TextBox"/>
            <p:cNvSpPr/>
            <p:nvPr/>
          </p:nvSpPr>
          <p:spPr>
            <a:xfrm>
              <a:off x="206280" y="10015560"/>
              <a:ext cx="38736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l-GR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Ομάδα 18"/>
          <p:cNvGrpSpPr/>
          <p:nvPr/>
        </p:nvGrpSpPr>
        <p:grpSpPr>
          <a:xfrm>
            <a:off x="214200" y="5581800"/>
            <a:ext cx="12765240" cy="4329000"/>
            <a:chOff x="214200" y="5581800"/>
            <a:chExt cx="12765240" cy="4329000"/>
          </a:xfrm>
        </p:grpSpPr>
        <p:sp>
          <p:nvSpPr>
            <p:cNvPr id="81" name="TextBox 4"/>
            <p:cNvSpPr/>
            <p:nvPr/>
          </p:nvSpPr>
          <p:spPr>
            <a:xfrm>
              <a:off x="5097600" y="5581800"/>
              <a:ext cx="2216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23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4"/>
            <p:cNvSpPr/>
            <p:nvPr/>
          </p:nvSpPr>
          <p:spPr>
            <a:xfrm>
              <a:off x="2525760" y="5581800"/>
              <a:ext cx="1890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</a:t>
              </a:r>
              <a:r>
                <a:rPr b="1" lang="el-GR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0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4"/>
            <p:cNvSpPr/>
            <p:nvPr/>
          </p:nvSpPr>
          <p:spPr>
            <a:xfrm>
              <a:off x="7722000" y="5581800"/>
              <a:ext cx="2216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46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4"/>
            <p:cNvSpPr/>
            <p:nvPr/>
          </p:nvSpPr>
          <p:spPr>
            <a:xfrm>
              <a:off x="10403640" y="5581800"/>
              <a:ext cx="2216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S57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71 - TextBox"/>
            <p:cNvSpPr/>
            <p:nvPr/>
          </p:nvSpPr>
          <p:spPr>
            <a:xfrm>
              <a:off x="214200" y="5590800"/>
              <a:ext cx="38736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l-GR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6" name="Picture 1" descr=""/>
            <p:cNvPicPr/>
            <p:nvPr/>
          </p:nvPicPr>
          <p:blipFill>
            <a:blip r:embed="rId9"/>
            <a:srcRect l="0" t="11132" r="0" b="0"/>
            <a:stretch/>
          </p:blipFill>
          <p:spPr>
            <a:xfrm>
              <a:off x="1854720" y="5962320"/>
              <a:ext cx="2842920" cy="37688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7" name="Group 21"/>
            <p:cNvGrpSpPr/>
            <p:nvPr/>
          </p:nvGrpSpPr>
          <p:grpSpPr>
            <a:xfrm>
              <a:off x="4561560" y="6120360"/>
              <a:ext cx="3160800" cy="3790440"/>
              <a:chOff x="4561560" y="6120360"/>
              <a:chExt cx="3160800" cy="3790440"/>
            </a:xfrm>
          </p:grpSpPr>
          <p:pic>
            <p:nvPicPr>
              <p:cNvPr id="88" name="Picture 2" descr=""/>
              <p:cNvPicPr/>
              <p:nvPr/>
            </p:nvPicPr>
            <p:blipFill>
              <a:blip r:embed="rId10"/>
              <a:srcRect l="0" t="9182" r="0" b="0"/>
              <a:stretch/>
            </p:blipFill>
            <p:spPr>
              <a:xfrm>
                <a:off x="4561560" y="6120360"/>
                <a:ext cx="3160800" cy="3790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9" name="Picture 16" descr=""/>
              <p:cNvPicPr/>
              <p:nvPr/>
            </p:nvPicPr>
            <p:blipFill>
              <a:blip r:embed="rId11"/>
              <a:srcRect l="45943" t="11228" r="38674" b="82759"/>
              <a:stretch/>
            </p:blipFill>
            <p:spPr>
              <a:xfrm>
                <a:off x="5934960" y="6158520"/>
                <a:ext cx="437760" cy="2282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90" name="Group 22"/>
            <p:cNvGrpSpPr/>
            <p:nvPr/>
          </p:nvGrpSpPr>
          <p:grpSpPr>
            <a:xfrm>
              <a:off x="10199880" y="6405480"/>
              <a:ext cx="2779560" cy="3460320"/>
              <a:chOff x="10199880" y="6405480"/>
              <a:chExt cx="2779560" cy="3460320"/>
            </a:xfrm>
          </p:grpSpPr>
          <p:pic>
            <p:nvPicPr>
              <p:cNvPr id="91" name="Picture 17" descr=""/>
              <p:cNvPicPr/>
              <p:nvPr/>
            </p:nvPicPr>
            <p:blipFill>
              <a:blip r:embed="rId12"/>
              <a:srcRect l="0" t="8716" r="0" b="0"/>
              <a:stretch/>
            </p:blipFill>
            <p:spPr>
              <a:xfrm>
                <a:off x="10199880" y="6405480"/>
                <a:ext cx="2779560" cy="3460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2" name="Picture 19" descr=""/>
              <p:cNvPicPr/>
              <p:nvPr/>
            </p:nvPicPr>
            <p:blipFill>
              <a:blip r:embed="rId13"/>
              <a:srcRect l="45943" t="11228" r="38674" b="82759"/>
              <a:stretch/>
            </p:blipFill>
            <p:spPr>
              <a:xfrm>
                <a:off x="11263680" y="6831000"/>
                <a:ext cx="437760" cy="228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3" name="Picture 20" descr=""/>
              <p:cNvPicPr/>
              <p:nvPr/>
            </p:nvPicPr>
            <p:blipFill>
              <a:blip r:embed="rId14"/>
              <a:srcRect l="40794" t="11547" r="35246" b="82727"/>
              <a:stretch/>
            </p:blipFill>
            <p:spPr>
              <a:xfrm>
                <a:off x="11360880" y="6456960"/>
                <a:ext cx="681120" cy="2174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94" name="Group 23"/>
            <p:cNvGrpSpPr/>
            <p:nvPr/>
          </p:nvGrpSpPr>
          <p:grpSpPr>
            <a:xfrm>
              <a:off x="7370280" y="6554880"/>
              <a:ext cx="3160800" cy="3322080"/>
              <a:chOff x="7370280" y="6554880"/>
              <a:chExt cx="3160800" cy="3322080"/>
            </a:xfrm>
          </p:grpSpPr>
          <p:pic>
            <p:nvPicPr>
              <p:cNvPr id="95" name="Picture 7" descr=""/>
              <p:cNvPicPr/>
              <p:nvPr/>
            </p:nvPicPr>
            <p:blipFill>
              <a:blip r:embed="rId15"/>
              <a:srcRect l="0" t="10340" r="0" b="0"/>
              <a:stretch/>
            </p:blipFill>
            <p:spPr>
              <a:xfrm>
                <a:off x="7370280" y="6554880"/>
                <a:ext cx="3160800" cy="3322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6" name="Picture 14" descr=""/>
              <p:cNvPicPr/>
              <p:nvPr/>
            </p:nvPicPr>
            <p:blipFill>
              <a:blip r:embed="rId16"/>
              <a:srcRect l="45943" t="11228" r="38674" b="82759"/>
              <a:stretch/>
            </p:blipFill>
            <p:spPr>
              <a:xfrm>
                <a:off x="8512560" y="7466040"/>
                <a:ext cx="437760" cy="228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Picture 15" descr=""/>
              <p:cNvPicPr/>
              <p:nvPr/>
            </p:nvPicPr>
            <p:blipFill>
              <a:blip r:embed="rId17"/>
              <a:srcRect l="45943" t="11228" r="38674" b="82759"/>
              <a:stretch/>
            </p:blipFill>
            <p:spPr>
              <a:xfrm>
                <a:off x="8764920" y="7009920"/>
                <a:ext cx="437760" cy="22824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6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9T11:22:21Z</dcterms:created>
  <dc:creator>Dell User</dc:creator>
  <dc:description/>
  <dc:language>en-US</dc:language>
  <cp:lastModifiedBy>Priya V.</cp:lastModifiedBy>
  <cp:lastPrinted>2023-01-20T17:09:44Z</cp:lastPrinted>
  <dcterms:modified xsi:type="dcterms:W3CDTF">2023-02-01T03:37:07Z</dcterms:modified>
  <cp:revision>364</cp:revision>
  <dc:subject/>
  <dc:title>PowerPoint Presentation</dc:title>
</cp:coreProperties>
</file>